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10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ls\Desktop\fig3%20neu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ls\Desktop\fig3%20neu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2800">
                <a:solidFill>
                  <a:sysClr val="windowText" lastClr="000000"/>
                </a:solidFill>
              </a:rPr>
              <a:t>ATN status per clinical diagnosi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ttau!$C$2</c:f>
              <c:strCache>
                <c:ptCount val="1"/>
                <c:pt idx="0">
                  <c:v>A-T-N-</c:v>
                </c:pt>
              </c:strCache>
            </c:strRef>
          </c:tx>
          <c:spPr>
            <a:solidFill>
              <a:srgbClr val="58BD8B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ttau!$B$3:$B$6</c:f>
              <c:strCache>
                <c:ptCount val="4"/>
                <c:pt idx="0">
                  <c:v>NC</c:v>
                </c:pt>
                <c:pt idx="1">
                  <c:v>SCD</c:v>
                </c:pt>
                <c:pt idx="2">
                  <c:v>MCI</c:v>
                </c:pt>
                <c:pt idx="3">
                  <c:v>DAT</c:v>
                </c:pt>
              </c:strCache>
            </c:strRef>
          </c:cat>
          <c:val>
            <c:numRef>
              <c:f>ttau!$C$3:$C$6</c:f>
              <c:numCache>
                <c:formatCode>General</c:formatCode>
                <c:ptCount val="4"/>
                <c:pt idx="0">
                  <c:v>66</c:v>
                </c:pt>
                <c:pt idx="1">
                  <c:v>85</c:v>
                </c:pt>
                <c:pt idx="2">
                  <c:v>19</c:v>
                </c:pt>
                <c:pt idx="3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EB-4F4B-ACC6-B81078FE1240}"/>
            </c:ext>
          </c:extLst>
        </c:ser>
        <c:ser>
          <c:idx val="1"/>
          <c:order val="1"/>
          <c:tx>
            <c:strRef>
              <c:f>ttau!$D$2</c:f>
              <c:strCache>
                <c:ptCount val="1"/>
                <c:pt idx="0">
                  <c:v>A+T-N-</c:v>
                </c:pt>
              </c:strCache>
            </c:strRef>
          </c:tx>
          <c:spPr>
            <a:solidFill>
              <a:srgbClr val="A5BE6A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ttau!$B$3:$B$6</c:f>
              <c:strCache>
                <c:ptCount val="4"/>
                <c:pt idx="0">
                  <c:v>NC</c:v>
                </c:pt>
                <c:pt idx="1">
                  <c:v>SCD</c:v>
                </c:pt>
                <c:pt idx="2">
                  <c:v>MCI</c:v>
                </c:pt>
                <c:pt idx="3">
                  <c:v>DAT</c:v>
                </c:pt>
              </c:strCache>
            </c:strRef>
          </c:cat>
          <c:val>
            <c:numRef>
              <c:f>ttau!$D$3:$D$6</c:f>
              <c:numCache>
                <c:formatCode>General</c:formatCode>
                <c:ptCount val="4"/>
                <c:pt idx="0">
                  <c:v>22</c:v>
                </c:pt>
                <c:pt idx="1">
                  <c:v>25</c:v>
                </c:pt>
                <c:pt idx="2">
                  <c:v>12</c:v>
                </c:pt>
                <c:pt idx="3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FEB-4F4B-ACC6-B81078FE1240}"/>
            </c:ext>
          </c:extLst>
        </c:ser>
        <c:ser>
          <c:idx val="2"/>
          <c:order val="2"/>
          <c:tx>
            <c:strRef>
              <c:f>ttau!$E$2</c:f>
              <c:strCache>
                <c:ptCount val="1"/>
                <c:pt idx="0">
                  <c:v>A+T+N-</c:v>
                </c:pt>
              </c:strCache>
            </c:strRef>
          </c:tx>
          <c:spPr>
            <a:solidFill>
              <a:srgbClr val="E1B952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ttau!$B$3:$B$6</c:f>
              <c:strCache>
                <c:ptCount val="4"/>
                <c:pt idx="0">
                  <c:v>NC</c:v>
                </c:pt>
                <c:pt idx="1">
                  <c:v>SCD</c:v>
                </c:pt>
                <c:pt idx="2">
                  <c:v>MCI</c:v>
                </c:pt>
                <c:pt idx="3">
                  <c:v>DAT</c:v>
                </c:pt>
              </c:strCache>
            </c:strRef>
          </c:cat>
          <c:val>
            <c:numRef>
              <c:f>ttau!$E$3:$E$6</c:f>
              <c:numCache>
                <c:formatCode>General</c:formatCode>
                <c:ptCount val="4"/>
                <c:pt idx="0">
                  <c:v>5</c:v>
                </c:pt>
                <c:pt idx="1">
                  <c:v>12</c:v>
                </c:pt>
                <c:pt idx="2">
                  <c:v>9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FEB-4F4B-ACC6-B81078FE1240}"/>
            </c:ext>
          </c:extLst>
        </c:ser>
        <c:ser>
          <c:idx val="3"/>
          <c:order val="3"/>
          <c:tx>
            <c:strRef>
              <c:f>ttau!$F$2</c:f>
              <c:strCache>
                <c:ptCount val="1"/>
                <c:pt idx="0">
                  <c:v>A+T-N+</c:v>
                </c:pt>
              </c:strCache>
            </c:strRef>
          </c:tx>
          <c:spPr>
            <a:solidFill>
              <a:srgbClr val="FBCD2D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ttau!$B$3:$B$6</c:f>
              <c:strCache>
                <c:ptCount val="4"/>
                <c:pt idx="0">
                  <c:v>NC</c:v>
                </c:pt>
                <c:pt idx="1">
                  <c:v>SCD</c:v>
                </c:pt>
                <c:pt idx="2">
                  <c:v>MCI</c:v>
                </c:pt>
                <c:pt idx="3">
                  <c:v>DAT</c:v>
                </c:pt>
              </c:strCache>
            </c:strRef>
          </c:cat>
          <c:val>
            <c:numRef>
              <c:f>ttau!$F$3:$F$6</c:f>
              <c:numCache>
                <c:formatCode>General</c:formatCode>
                <c:ptCount val="4"/>
                <c:pt idx="0">
                  <c:v>1</c:v>
                </c:pt>
                <c:pt idx="1">
                  <c:v>3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FEB-4F4B-ACC6-B81078FE1240}"/>
            </c:ext>
          </c:extLst>
        </c:ser>
        <c:ser>
          <c:idx val="4"/>
          <c:order val="4"/>
          <c:tx>
            <c:strRef>
              <c:f>ttau!$G$2</c:f>
              <c:strCache>
                <c:ptCount val="1"/>
                <c:pt idx="0">
                  <c:v>A+T+N+</c:v>
                </c:pt>
              </c:strCache>
            </c:strRef>
          </c:tx>
          <c:spPr>
            <a:solidFill>
              <a:srgbClr val="F8FA0D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ttau!$B$3:$B$6</c:f>
              <c:strCache>
                <c:ptCount val="4"/>
                <c:pt idx="0">
                  <c:v>NC</c:v>
                </c:pt>
                <c:pt idx="1">
                  <c:v>SCD</c:v>
                </c:pt>
                <c:pt idx="2">
                  <c:v>MCI</c:v>
                </c:pt>
                <c:pt idx="3">
                  <c:v>DAT</c:v>
                </c:pt>
              </c:strCache>
            </c:strRef>
          </c:cat>
          <c:val>
            <c:numRef>
              <c:f>ttau!$G$3:$G$6</c:f>
              <c:numCache>
                <c:formatCode>General</c:formatCode>
                <c:ptCount val="4"/>
                <c:pt idx="0">
                  <c:v>10</c:v>
                </c:pt>
                <c:pt idx="1">
                  <c:v>25</c:v>
                </c:pt>
                <c:pt idx="2">
                  <c:v>36</c:v>
                </c:pt>
                <c:pt idx="3">
                  <c:v>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FEB-4F4B-ACC6-B81078FE1240}"/>
            </c:ext>
          </c:extLst>
        </c:ser>
        <c:ser>
          <c:idx val="5"/>
          <c:order val="5"/>
          <c:tx>
            <c:strRef>
              <c:f>ttau!$H$2</c:f>
              <c:strCache>
                <c:ptCount val="1"/>
                <c:pt idx="0">
                  <c:v>non-AD-continuum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ttau!$B$3:$B$6</c:f>
              <c:strCache>
                <c:ptCount val="4"/>
                <c:pt idx="0">
                  <c:v>NC</c:v>
                </c:pt>
                <c:pt idx="1">
                  <c:v>SCD</c:v>
                </c:pt>
                <c:pt idx="2">
                  <c:v>MCI</c:v>
                </c:pt>
                <c:pt idx="3">
                  <c:v>DAT</c:v>
                </c:pt>
              </c:strCache>
            </c:strRef>
          </c:cat>
          <c:val>
            <c:numRef>
              <c:f>ttau!$H$3:$H$6</c:f>
              <c:numCache>
                <c:formatCode>General</c:formatCode>
                <c:ptCount val="4"/>
                <c:pt idx="0">
                  <c:v>23</c:v>
                </c:pt>
                <c:pt idx="1">
                  <c:v>18</c:v>
                </c:pt>
                <c:pt idx="2">
                  <c:v>1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FEB-4F4B-ACC6-B81078FE12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608374960"/>
        <c:axId val="608376272"/>
      </c:barChart>
      <c:catAx>
        <c:axId val="608374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08376272"/>
        <c:crosses val="autoZero"/>
        <c:auto val="1"/>
        <c:lblAlgn val="ctr"/>
        <c:lblOffset val="100"/>
        <c:noMultiLvlLbl val="0"/>
      </c:catAx>
      <c:valAx>
        <c:axId val="6083762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800">
                    <a:solidFill>
                      <a:sysClr val="windowText" lastClr="000000"/>
                    </a:solidFill>
                  </a:rPr>
                  <a:t>Percentage of subjec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083749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6.8745705115484224E-2"/>
          <c:y val="0.94643512406505648"/>
          <c:w val="0.9"/>
          <c:h val="4.245143777553888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2800">
                <a:solidFill>
                  <a:sysClr val="windowText" lastClr="000000"/>
                </a:solidFill>
              </a:rPr>
              <a:t>clinical diagnosis per ATN statu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ttau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rgbClr val="58BD8B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(ttau!$C$2:$E$2,ttau!$G$2)</c:f>
              <c:strCache>
                <c:ptCount val="4"/>
                <c:pt idx="0">
                  <c:v>A-T-N-</c:v>
                </c:pt>
                <c:pt idx="1">
                  <c:v>A+T-N-</c:v>
                </c:pt>
                <c:pt idx="2">
                  <c:v>A+T+N-</c:v>
                </c:pt>
                <c:pt idx="3">
                  <c:v>A+T+N+</c:v>
                </c:pt>
              </c:strCache>
              <c:extLst/>
            </c:strRef>
          </c:cat>
          <c:val>
            <c:numRef>
              <c:f>(ttau!$C$3:$E$3,ttau!$G$3)</c:f>
              <c:numCache>
                <c:formatCode>General</c:formatCode>
                <c:ptCount val="4"/>
                <c:pt idx="0">
                  <c:v>66</c:v>
                </c:pt>
                <c:pt idx="1">
                  <c:v>22</c:v>
                </c:pt>
                <c:pt idx="2">
                  <c:v>5</c:v>
                </c:pt>
                <c:pt idx="3">
                  <c:v>1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0AD0-4506-8762-1E4B06ACFABE}"/>
            </c:ext>
          </c:extLst>
        </c:ser>
        <c:ser>
          <c:idx val="1"/>
          <c:order val="1"/>
          <c:tx>
            <c:strRef>
              <c:f>ttau!$B$4</c:f>
              <c:strCache>
                <c:ptCount val="1"/>
                <c:pt idx="0">
                  <c:v>SCD</c:v>
                </c:pt>
              </c:strCache>
            </c:strRef>
          </c:tx>
          <c:spPr>
            <a:solidFill>
              <a:srgbClr val="A5BE6A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(ttau!$C$2:$E$2,ttau!$G$2)</c:f>
              <c:strCache>
                <c:ptCount val="4"/>
                <c:pt idx="0">
                  <c:v>A-T-N-</c:v>
                </c:pt>
                <c:pt idx="1">
                  <c:v>A+T-N-</c:v>
                </c:pt>
                <c:pt idx="2">
                  <c:v>A+T+N-</c:v>
                </c:pt>
                <c:pt idx="3">
                  <c:v>A+T+N+</c:v>
                </c:pt>
              </c:strCache>
              <c:extLst/>
            </c:strRef>
          </c:cat>
          <c:val>
            <c:numRef>
              <c:f>(ttau!$C$4:$E$4,ttau!$G$4)</c:f>
              <c:numCache>
                <c:formatCode>General</c:formatCode>
                <c:ptCount val="4"/>
                <c:pt idx="0">
                  <c:v>85</c:v>
                </c:pt>
                <c:pt idx="1">
                  <c:v>25</c:v>
                </c:pt>
                <c:pt idx="2">
                  <c:v>12</c:v>
                </c:pt>
                <c:pt idx="3">
                  <c:v>2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0AD0-4506-8762-1E4B06ACFABE}"/>
            </c:ext>
          </c:extLst>
        </c:ser>
        <c:ser>
          <c:idx val="2"/>
          <c:order val="2"/>
          <c:tx>
            <c:strRef>
              <c:f>ttau!$B$5</c:f>
              <c:strCache>
                <c:ptCount val="1"/>
                <c:pt idx="0">
                  <c:v>MCI</c:v>
                </c:pt>
              </c:strCache>
            </c:strRef>
          </c:tx>
          <c:spPr>
            <a:solidFill>
              <a:srgbClr val="E1B952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(ttau!$C$2:$E$2,ttau!$G$2)</c:f>
              <c:strCache>
                <c:ptCount val="4"/>
                <c:pt idx="0">
                  <c:v>A-T-N-</c:v>
                </c:pt>
                <c:pt idx="1">
                  <c:v>A+T-N-</c:v>
                </c:pt>
                <c:pt idx="2">
                  <c:v>A+T+N-</c:v>
                </c:pt>
                <c:pt idx="3">
                  <c:v>A+T+N+</c:v>
                </c:pt>
              </c:strCache>
              <c:extLst/>
            </c:strRef>
          </c:cat>
          <c:val>
            <c:numRef>
              <c:f>(ttau!$C$5:$E$5,ttau!$G$5)</c:f>
              <c:numCache>
                <c:formatCode>General</c:formatCode>
                <c:ptCount val="4"/>
                <c:pt idx="0">
                  <c:v>19</c:v>
                </c:pt>
                <c:pt idx="1">
                  <c:v>12</c:v>
                </c:pt>
                <c:pt idx="2">
                  <c:v>9</c:v>
                </c:pt>
                <c:pt idx="3">
                  <c:v>36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0AD0-4506-8762-1E4B06ACFABE}"/>
            </c:ext>
          </c:extLst>
        </c:ser>
        <c:ser>
          <c:idx val="3"/>
          <c:order val="3"/>
          <c:tx>
            <c:strRef>
              <c:f>ttau!$B$6</c:f>
              <c:strCache>
                <c:ptCount val="1"/>
                <c:pt idx="0">
                  <c:v>DAT</c:v>
                </c:pt>
              </c:strCache>
            </c:strRef>
          </c:tx>
          <c:spPr>
            <a:solidFill>
              <a:srgbClr val="F8FA0D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(ttau!$C$2:$E$2,ttau!$G$2)</c:f>
              <c:strCache>
                <c:ptCount val="4"/>
                <c:pt idx="0">
                  <c:v>A-T-N-</c:v>
                </c:pt>
                <c:pt idx="1">
                  <c:v>A+T-N-</c:v>
                </c:pt>
                <c:pt idx="2">
                  <c:v>A+T+N-</c:v>
                </c:pt>
                <c:pt idx="3">
                  <c:v>A+T+N+</c:v>
                </c:pt>
              </c:strCache>
              <c:extLst/>
            </c:strRef>
          </c:cat>
          <c:val>
            <c:numRef>
              <c:f>(ttau!$C$6:$E$6,ttau!$G$6)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2</c:v>
                </c:pt>
                <c:pt idx="3">
                  <c:v>4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0AD0-4506-8762-1E4B06ACFA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608374960"/>
        <c:axId val="608376272"/>
      </c:barChart>
      <c:catAx>
        <c:axId val="608374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08376272"/>
        <c:crosses val="autoZero"/>
        <c:auto val="1"/>
        <c:lblAlgn val="ctr"/>
        <c:lblOffset val="100"/>
        <c:noMultiLvlLbl val="0"/>
      </c:catAx>
      <c:valAx>
        <c:axId val="6083762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800">
                    <a:solidFill>
                      <a:sysClr val="windowText" lastClr="000000"/>
                    </a:solidFill>
                  </a:rPr>
                  <a:t>Percentage of subjec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083749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CD20E9C-73B7-810C-9251-A78ECBBB1E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5F794C61-ABDB-1412-D4B4-9D444400B6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8694BF0-E36B-A5E2-9E29-67639C42B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59E1D15-C2D5-BC3C-26F9-B18167830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0451497-C6D8-694A-8403-AEB161FFC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6371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A0A16CE-5589-B24A-AE05-DC0FFB3EBD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41B8323-6021-4B69-DE1A-3BF5CB194C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E30265F-8AFE-7F02-27AA-DAEE3E082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2A41234-BDC5-6472-0ED7-904E0DDC3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FF0BC19-1F5B-5A43-00BF-5B74845A9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0405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477F1C6-4CA0-E9D1-C1B1-A2680682C8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A0558D1-E430-53A3-6175-952E4A1EFF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6B7F281-FEDB-B5AC-B4E3-D3FA76892E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22F94EA-F2B2-20F4-8384-F4A70036D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608E346-FEB8-DA73-D8AE-984ED6CFB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9272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BC60D35-1D8B-F55B-22E6-BD144F5F03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AE50355-7522-F63B-F8EF-AD2828C910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77D382B-1F0A-7986-C926-2FD7C8F53C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B7C12D9-C707-5A9A-849E-8782A9F47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C780F58-3DCD-8A3C-32CE-B65E10895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5006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66CBA34-1363-354D-88CA-24440C02CD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A107835-BFEA-B02E-FC2C-BC407C8DE6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FDAC1F1-CE3C-44F6-9626-17B6D24AD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67A666F-4094-9E94-083D-7916D54F4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DA2596B-25E7-8057-8142-DF4B47BE9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5494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56DA5F6-DAE1-50AD-1C2A-6BEA439C97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CBC97F9-037E-512D-B3BC-3F07D554CE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589F799-DC05-8452-B4B2-F01ECF5633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53D5B1A-1810-4D70-C36F-FFC1B12BD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2FF5572-AA0D-6F12-1D68-95A2DD174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CDC0D2D-FFC1-BD1B-7320-07760AFDB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9815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CF6E8F-0C4E-4BF2-30A0-E0BCC14D05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EEDA661-208B-AD83-2FE0-2239995937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37C0F38-3061-D146-2D7E-B9A48BE188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10B6653-8A98-B59B-8756-1D55910FD8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5CFB96CD-16A4-AB59-47DC-5A85EABBEB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E6F4999-BC49-10E6-1FE3-2CF70B6A1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A69AF90-0F31-C667-3CCE-C332332CF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6221F47-12D4-59AD-D5F9-FEE65D204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8520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F9D28B-9DBB-013B-1A8D-EFF968287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CDD5C30E-026E-853F-4AD7-D94EDA529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F761C31-A64A-D18F-4A65-8896CF7C2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8453CBF-6A4A-D881-633C-9EB4A4F72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3463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35FCA32-D0B9-BF48-42BC-DEAD7E3A9E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8E350494-A171-9D2C-292E-B105C691A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CD3911D7-4E7D-229C-76F1-D0B5D3524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3824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BA0C7A-910A-B7F8-D78C-7B590A9214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D11C3B0-341E-2C4A-D939-F62E01009F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063A144-CFFF-0E58-06F3-D8EC72450F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F6A6F1D-8711-19DE-A41C-FD5871569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B8F081B-DEF1-4406-D99F-FBBA5B248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BF3E54E-4F31-F69D-5EE2-61AAFB4B3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2182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EBD194-9861-5D5D-9869-D5866767E2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AB87CDA8-ED22-A9E8-949E-1B15D49C82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6A8521A-6BC9-EB97-C0E0-FBC0062F20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749CBA6-BBDB-3BED-D2BC-B777574E8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B63B3D6-2C63-C28D-78C8-AD5B9D4CC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9930653-8A88-06AB-FB5C-315DF6079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1237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0C4C2496-3949-08F0-427E-24BF0863B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5F27CEE-02F7-1E25-7035-8D245875EC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8C62BA5-0D71-97C2-5255-89CA47503A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4EFAB-7F59-43E9-8A75-4CA0803F9F59}" type="datetimeFigureOut">
              <a:rPr lang="de-DE" smtClean="0"/>
              <a:t>26.0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5FD7D23-333B-59AF-3B21-DF0B4E93F5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E8A017-6048-3687-47C6-38C371C294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4EEEC-7797-415B-9BB9-3EC401E904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9129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2BF52069-50B4-F4B9-6F30-D6FE919470FC}"/>
              </a:ext>
            </a:extLst>
          </p:cNvPr>
          <p:cNvGrpSpPr/>
          <p:nvPr/>
        </p:nvGrpSpPr>
        <p:grpSpPr>
          <a:xfrm>
            <a:off x="0" y="0"/>
            <a:ext cx="12194740" cy="6858000"/>
            <a:chOff x="2303545" y="1633913"/>
            <a:chExt cx="7584910" cy="3590174"/>
          </a:xfrm>
        </p:grpSpPr>
        <p:graphicFrame>
          <p:nvGraphicFramePr>
            <p:cNvPr id="4" name="Diagramm 3">
              <a:extLst>
                <a:ext uri="{FF2B5EF4-FFF2-40B4-BE49-F238E27FC236}">
                  <a16:creationId xmlns:a16="http://schemas.microsoft.com/office/drawing/2014/main" id="{1B059F68-AD62-4157-8826-AC6B0667D38A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303545" y="1633913"/>
            <a:ext cx="3792455" cy="35894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Diagramm 4">
              <a:extLst>
                <a:ext uri="{FF2B5EF4-FFF2-40B4-BE49-F238E27FC236}">
                  <a16:creationId xmlns:a16="http://schemas.microsoft.com/office/drawing/2014/main" id="{E86C5D41-2842-43A7-8871-66C372DEF21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096000" y="1633913"/>
            <a:ext cx="3792455" cy="35901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489046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Breitbild</PresentationFormat>
  <Paragraphs>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ls Heinzinger</dc:creator>
  <cp:lastModifiedBy>Nils Heinzinger</cp:lastModifiedBy>
  <cp:revision>1</cp:revision>
  <dcterms:created xsi:type="dcterms:W3CDTF">2023-02-26T19:43:21Z</dcterms:created>
  <dcterms:modified xsi:type="dcterms:W3CDTF">2023-02-26T19:43:35Z</dcterms:modified>
</cp:coreProperties>
</file>